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5759450" cy="25193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-488880" y="685440"/>
            <a:ext cx="78357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187"/>
              </a:spcBef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fld id="{FD618AAB-CDA3-46A7-AF55-085DFDF5E57F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-488880" y="685800"/>
            <a:ext cx="7835760" cy="342900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187"/>
              </a:spcBef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GB" sz="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fld id="{ED1ED23C-D1FA-4823-9C45-86A51665E082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C4562-93DD-4EC8-ABA9-ED298B7DFF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518652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86920" y="1457640"/>
            <a:ext cx="518652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04720-B239-4B41-87F0-D43CCF25F1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944800" y="58860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86920" y="145764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944800" y="145764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A1FF8-F502-46C4-B4C4-008AE64693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166968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040480" y="588600"/>
            <a:ext cx="166968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794040" y="588600"/>
            <a:ext cx="166968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86920" y="1457640"/>
            <a:ext cx="166968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040480" y="1457640"/>
            <a:ext cx="166968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794040" y="1457640"/>
            <a:ext cx="166968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A1903-A9FC-4A2B-BDD7-A9F6034460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86920" y="588600"/>
            <a:ext cx="5186520" cy="1663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26"/>
              </a:spcBef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3EB84-68F7-44B6-9BD7-8A037304F7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5186520" cy="166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78E620-1FAA-4972-BCA5-877C134F39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2530800" cy="166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944800" y="588600"/>
            <a:ext cx="2530800" cy="166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EBB5C-70E7-4021-AE08-E213EA2AA4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673F8-8895-4B82-8436-973D244ABE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86920" y="101520"/>
            <a:ext cx="5186520" cy="1943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26"/>
              </a:spcBef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43737-A9FF-4C96-B80C-BE9933926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944800" y="588600"/>
            <a:ext cx="2530800" cy="166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86920" y="145764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9B096B-797E-43DE-98D4-0DCCAD456A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2530800" cy="166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944800" y="58860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944800" y="145764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A65644-48CD-434F-9F7D-440B04CBAE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86920" y="58860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944800" y="588600"/>
            <a:ext cx="253080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86920" y="1457640"/>
            <a:ext cx="5186520" cy="7934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/>
          </a:bodyPr>
          <a:p>
            <a:pPr indent="0">
              <a:spcBef>
                <a:spcPts val="326"/>
              </a:spcBef>
              <a:buNone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BF891-1952-4F1D-A10E-766FEDD1E4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86920" y="101520"/>
            <a:ext cx="5186520" cy="41904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 algn="ctr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86920" y="588600"/>
            <a:ext cx="5186520" cy="166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t">
            <a:normAutofit fontScale="99000"/>
          </a:bodyPr>
          <a:p>
            <a:pPr marL="136800" indent="-136800">
              <a:spcBef>
                <a:spcPts val="326"/>
              </a:spcBef>
              <a:buClr>
                <a:srgbClr val="000000"/>
              </a:buClr>
              <a:buFont typeface="Arial"/>
              <a:buChar char="•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lvl="1" marL="296640" indent="-112680">
              <a:spcBef>
                <a:spcPts val="326"/>
              </a:spcBef>
              <a:buClr>
                <a:srgbClr val="000000"/>
              </a:buClr>
              <a:buFont typeface="Arial"/>
              <a:buChar char="–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lvl="2" marL="457200" indent="-91080">
              <a:spcBef>
                <a:spcPts val="326"/>
              </a:spcBef>
              <a:buClr>
                <a:srgbClr val="000000"/>
              </a:buClr>
              <a:buFont typeface="Arial"/>
              <a:buChar char="•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lvl="3" marL="641160" indent="-91080">
              <a:spcBef>
                <a:spcPts val="326"/>
              </a:spcBef>
              <a:buClr>
                <a:srgbClr val="000000"/>
              </a:buClr>
              <a:buFont typeface="Arial"/>
              <a:buChar char="–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lvl="4" marL="823320" indent="-91080">
              <a:spcBef>
                <a:spcPts val="326"/>
              </a:spcBef>
              <a:buClr>
                <a:srgbClr val="000000"/>
              </a:buClr>
              <a:buFont typeface="Arial"/>
              <a:buChar char="»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lvl="5" marL="823320" indent="-91080">
              <a:spcBef>
                <a:spcPts val="326"/>
              </a:spcBef>
              <a:buClr>
                <a:srgbClr val="000000"/>
              </a:buClr>
              <a:buFont typeface="Arial"/>
              <a:buChar char="»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  <a:p>
            <a:pPr lvl="6" marL="823320" indent="-91080">
              <a:spcBef>
                <a:spcPts val="326"/>
              </a:spcBef>
              <a:buClr>
                <a:srgbClr val="000000"/>
              </a:buClr>
              <a:buFont typeface="Arial"/>
              <a:buChar char="»"/>
              <a:tabLst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86920" y="2336400"/>
            <a:ext cx="1344600" cy="13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  <a:defRPr b="0" lang="en-GB" sz="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r>
              <a:rPr b="0" lang="en-GB" sz="5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68120" y="2336400"/>
            <a:ext cx="1824120" cy="13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p>
            <a:pPr indent="0"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128840" y="2336400"/>
            <a:ext cx="1344600" cy="133560"/>
          </a:xfrm>
          <a:prstGeom prst="rect">
            <a:avLst/>
          </a:prstGeom>
          <a:noFill/>
          <a:ln w="0">
            <a:noFill/>
          </a:ln>
        </p:spPr>
        <p:txBody>
          <a:bodyPr lIns="37080" rIns="37080" tIns="18360" bIns="1836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  <a:defRPr b="0" lang="en-GB" sz="5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369720"/>
                <a:tab algn="l" pos="739800"/>
                <a:tab algn="l" pos="1109520"/>
                <a:tab algn="l" pos="1479600"/>
                <a:tab algn="l" pos="1849320"/>
                <a:tab algn="l" pos="2219400"/>
                <a:tab algn="l" pos="2589120"/>
                <a:tab algn="l" pos="2959200"/>
                <a:tab algn="l" pos="3328920"/>
                <a:tab algn="l" pos="3699000"/>
                <a:tab algn="l" pos="4068720"/>
                <a:tab algn="l" pos="4438800"/>
                <a:tab algn="l" pos="4808520"/>
                <a:tab algn="l" pos="5178600"/>
                <a:tab algn="l" pos="5548320"/>
                <a:tab algn="l" pos="5918040"/>
                <a:tab algn="l" pos="6288120"/>
                <a:tab algn="l" pos="6657840"/>
                <a:tab algn="l" pos="7027920"/>
                <a:tab algn="l" pos="7397640"/>
              </a:tabLst>
            </a:pPr>
            <a:fld id="{895DDA21-9F28-4887-B6FA-A92AD42D0FFB}" type="slidenum">
              <a:rPr b="0" lang="en-GB" sz="5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55"/>
          <p:cNvGrpSpPr/>
          <p:nvPr/>
        </p:nvGrpSpPr>
        <p:grpSpPr>
          <a:xfrm>
            <a:off x="176040" y="210960"/>
            <a:ext cx="5410080" cy="2098440"/>
            <a:chOff x="176040" y="210960"/>
            <a:chExt cx="5410080" cy="2098440"/>
          </a:xfrm>
        </p:grpSpPr>
        <p:sp>
          <p:nvSpPr>
            <p:cNvPr id="49" name="Rectangle 176"/>
            <p:cNvSpPr/>
            <p:nvPr/>
          </p:nvSpPr>
          <p:spPr>
            <a:xfrm>
              <a:off x="1662120" y="1910880"/>
              <a:ext cx="3924000" cy="39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‘-TTTTT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Arial"/>
                </a:rPr>
                <a:t>CTCGAG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CACACCACCACCACCACCACCTTAG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ATAAACCTATCATATATGTACC-3'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75"/>
            <p:cNvSpPr/>
            <p:nvPr/>
          </p:nvSpPr>
          <p:spPr>
            <a:xfrm>
              <a:off x="176040" y="2004840"/>
              <a:ext cx="1486080" cy="22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w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mLspAr (Xho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74"/>
            <p:cNvSpPr/>
            <p:nvPr/>
          </p:nvSpPr>
          <p:spPr>
            <a:xfrm>
              <a:off x="1662120" y="1668240"/>
              <a:ext cx="392400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'-TTTTT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Arial"/>
                </a:rPr>
                <a:t>GGATCC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GAAAAAACTATGCTTGATTATTACACC-3'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73"/>
            <p:cNvSpPr/>
            <p:nvPr/>
          </p:nvSpPr>
          <p:spPr>
            <a:xfrm>
              <a:off x="176040" y="1668240"/>
              <a:ext cx="148608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w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mLspAf (BamH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71"/>
            <p:cNvSpPr/>
            <p:nvPr/>
          </p:nvSpPr>
          <p:spPr>
            <a:xfrm>
              <a:off x="176040" y="1425240"/>
              <a:ext cx="312408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loning into pGEX5.1 expression vec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70"/>
            <p:cNvSpPr/>
            <p:nvPr/>
          </p:nvSpPr>
          <p:spPr>
            <a:xfrm>
              <a:off x="1662120" y="1182240"/>
              <a:ext cx="392400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'-TTTTT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Arial"/>
                </a:rPr>
                <a:t>CTCGAG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TATTGTTTTTTCGCTCTAGAAGG-3'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69"/>
            <p:cNvSpPr/>
            <p:nvPr/>
          </p:nvSpPr>
          <p:spPr>
            <a:xfrm>
              <a:off x="176040" y="1182240"/>
              <a:ext cx="148608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Ec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spAr (Xho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168"/>
            <p:cNvSpPr/>
            <p:nvPr/>
          </p:nvSpPr>
          <p:spPr>
            <a:xfrm>
              <a:off x="1662120" y="939600"/>
              <a:ext cx="392400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'-TTTTT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Arial"/>
                </a:rPr>
                <a:t>CATATG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GTCAATCGATCTGTTCAACC-3'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167"/>
            <p:cNvSpPr/>
            <p:nvPr/>
          </p:nvSpPr>
          <p:spPr>
            <a:xfrm>
              <a:off x="176040" y="939600"/>
              <a:ext cx="148608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Ec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spAf (Nde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66"/>
            <p:cNvSpPr/>
            <p:nvPr/>
          </p:nvSpPr>
          <p:spPr>
            <a:xfrm>
              <a:off x="1662120" y="696600"/>
              <a:ext cx="392400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'-TTTTT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Arial"/>
                </a:rPr>
                <a:t>CTCGAG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TTAGAAATAAACCTATCATATATGTACC-3'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65"/>
            <p:cNvSpPr/>
            <p:nvPr/>
          </p:nvSpPr>
          <p:spPr>
            <a:xfrm>
              <a:off x="176040" y="696600"/>
              <a:ext cx="148608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w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mLspAr (Xho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64"/>
            <p:cNvSpPr/>
            <p:nvPr/>
          </p:nvSpPr>
          <p:spPr>
            <a:xfrm>
              <a:off x="1662120" y="453600"/>
              <a:ext cx="392400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'-TTTTT</a:t>
              </a:r>
              <a:r>
                <a:rPr b="0" lang="en-US" sz="1000" spc="-1" strike="noStrike" u="sng">
                  <a:solidFill>
                    <a:srgbClr val="000000"/>
                  </a:solidFill>
                  <a:uFillTx/>
                  <a:latin typeface="Arial"/>
                </a:rPr>
                <a:t>CATATG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AAAAACTATGCTTGATTATTACACC-3'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63"/>
            <p:cNvSpPr/>
            <p:nvPr/>
          </p:nvSpPr>
          <p:spPr>
            <a:xfrm>
              <a:off x="176040" y="453600"/>
              <a:ext cx="148608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w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mLspAf (NdeI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161"/>
            <p:cNvSpPr/>
            <p:nvPr/>
          </p:nvSpPr>
          <p:spPr>
            <a:xfrm>
              <a:off x="176040" y="210960"/>
              <a:ext cx="3048120" cy="24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marL="343080" indent="-343080">
                <a:tabLst>
                  <a:tab algn="l" pos="0"/>
                  <a:tab algn="l" pos="369720"/>
                  <a:tab algn="l" pos="739800"/>
                  <a:tab algn="l" pos="1109520"/>
                  <a:tab algn="l" pos="1479600"/>
                  <a:tab algn="l" pos="1849320"/>
                  <a:tab algn="l" pos="2219400"/>
                  <a:tab algn="l" pos="2589120"/>
                  <a:tab algn="l" pos="2959200"/>
                  <a:tab algn="l" pos="3328920"/>
                  <a:tab algn="l" pos="3699000"/>
                  <a:tab algn="l" pos="4068720"/>
                  <a:tab algn="l" pos="4438800"/>
                  <a:tab algn="l" pos="4808520"/>
                  <a:tab algn="l" pos="5178600"/>
                  <a:tab algn="l" pos="5548320"/>
                  <a:tab algn="l" pos="5918040"/>
                  <a:tab algn="l" pos="6288120"/>
                  <a:tab algn="l" pos="6657840"/>
                  <a:tab algn="l" pos="7027920"/>
                  <a:tab algn="l" pos="739764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loning into pET21a+ expression vecto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77"/>
            <p:cNvSpPr/>
            <p:nvPr/>
          </p:nvSpPr>
          <p:spPr>
            <a:xfrm>
              <a:off x="176040" y="21096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178"/>
            <p:cNvSpPr/>
            <p:nvPr/>
          </p:nvSpPr>
          <p:spPr>
            <a:xfrm>
              <a:off x="176040" y="230652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179"/>
            <p:cNvSpPr/>
            <p:nvPr/>
          </p:nvSpPr>
          <p:spPr>
            <a:xfrm>
              <a:off x="176040" y="210960"/>
              <a:ext cx="0" cy="209556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80"/>
            <p:cNvSpPr/>
            <p:nvPr/>
          </p:nvSpPr>
          <p:spPr>
            <a:xfrm>
              <a:off x="5586120" y="210960"/>
              <a:ext cx="0" cy="209556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183"/>
            <p:cNvSpPr/>
            <p:nvPr/>
          </p:nvSpPr>
          <p:spPr>
            <a:xfrm>
              <a:off x="176040" y="45360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185"/>
            <p:cNvSpPr/>
            <p:nvPr/>
          </p:nvSpPr>
          <p:spPr>
            <a:xfrm>
              <a:off x="1662120" y="453600"/>
              <a:ext cx="2880" cy="96516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965160"/>
                <a:gd name="textAreaBottom" fmla="*/ 965520 h 965160"/>
              </a:gdLst>
              <a:ahLst/>
              <a:rect l="textAreaLeft" t="textAreaTop" r="textAreaRight" b="textAreaBottom"/>
              <a:pathLst>
                <a:path w="2" h="608">
                  <a:moveTo>
                    <a:pt x="0" y="0"/>
                  </a:moveTo>
                  <a:lnTo>
                    <a:pt x="2" y="608"/>
                  </a:lnTo>
                </a:path>
              </a:pathLst>
            </a:custGeom>
            <a:noFill/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89"/>
            <p:cNvSpPr/>
            <p:nvPr/>
          </p:nvSpPr>
          <p:spPr>
            <a:xfrm>
              <a:off x="176040" y="69660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97"/>
            <p:cNvSpPr/>
            <p:nvPr/>
          </p:nvSpPr>
          <p:spPr>
            <a:xfrm>
              <a:off x="176040" y="93960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205"/>
            <p:cNvSpPr/>
            <p:nvPr/>
          </p:nvSpPr>
          <p:spPr>
            <a:xfrm>
              <a:off x="176040" y="118224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213"/>
            <p:cNvSpPr/>
            <p:nvPr/>
          </p:nvSpPr>
          <p:spPr>
            <a:xfrm>
              <a:off x="176040" y="142524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221"/>
            <p:cNvSpPr/>
            <p:nvPr/>
          </p:nvSpPr>
          <p:spPr>
            <a:xfrm>
              <a:off x="176040" y="166824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229"/>
            <p:cNvSpPr/>
            <p:nvPr/>
          </p:nvSpPr>
          <p:spPr>
            <a:xfrm>
              <a:off x="176040" y="1910880"/>
              <a:ext cx="54100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253"/>
            <p:cNvSpPr/>
            <p:nvPr/>
          </p:nvSpPr>
          <p:spPr>
            <a:xfrm>
              <a:off x="1665000" y="1671480"/>
              <a:ext cx="1800" cy="63792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37920"/>
                <a:gd name="textAreaBottom" fmla="*/ 638280 h 637920"/>
              </a:gdLst>
              <a:ahLst/>
              <a:rect l="textAreaLeft" t="textAreaTop" r="textAreaRight" b="textAreaBottom"/>
              <a:pathLst>
                <a:path w="1" h="402">
                  <a:moveTo>
                    <a:pt x="0" y="0"/>
                  </a:moveTo>
                  <a:lnTo>
                    <a:pt x="0" y="402"/>
                  </a:lnTo>
                </a:path>
              </a:pathLst>
            </a:custGeom>
            <a:noFill/>
            <a:ln cap="rnd"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27T14:41:56Z</dcterms:created>
  <dc:creator>Kelly</dc:creator>
  <dc:description/>
  <dc:language>en-US</dc:language>
  <cp:lastModifiedBy>Kelly</cp:lastModifiedBy>
  <dcterms:modified xsi:type="dcterms:W3CDTF">2010-10-13T10:39:32Z</dcterms:modified>
  <cp:revision>2</cp:revision>
  <dc:subject/>
  <dc:title>Slide 1</dc:title>
</cp:coreProperties>
</file>